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61" r:id="rId2"/>
    <p:sldId id="266" r:id="rId3"/>
    <p:sldId id="264" r:id="rId4"/>
    <p:sldId id="262" r:id="rId5"/>
    <p:sldId id="263" r:id="rId6"/>
    <p:sldId id="267" r:id="rId7"/>
    <p:sldId id="265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8AD3"/>
    <a:srgbClr val="7CA0D5"/>
    <a:srgbClr val="0000FF"/>
    <a:srgbClr val="04C0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68"/>
    <p:restoredTop sz="92378"/>
  </p:normalViewPr>
  <p:slideViewPr>
    <p:cSldViewPr snapToGrid="0">
      <p:cViewPr>
        <p:scale>
          <a:sx n="125" d="100"/>
          <a:sy n="125" d="100"/>
        </p:scale>
        <p:origin x="2664" y="-25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F43EF8-2F2D-224D-9FD2-D6E554DD060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9B01D3-3570-6F45-A89E-F1106172C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3505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727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202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825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099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082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3724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0357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046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909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586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983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403E53-4550-094D-BCFB-3C1E24367ECB}" type="datetimeFigureOut">
              <a:rPr lang="en-US" smtClean="0"/>
              <a:t>10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1A6CDF-6590-FB49-B5CE-FE52796E40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515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9.png"/><Relationship Id="rId7" Type="http://schemas.openxmlformats.org/officeDocument/2006/relationships/image" Target="../media/image11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8.emf"/><Relationship Id="rId11" Type="http://schemas.openxmlformats.org/officeDocument/2006/relationships/image" Target="../media/image15.png"/><Relationship Id="rId5" Type="http://schemas.openxmlformats.org/officeDocument/2006/relationships/oleObject" Target="../embeddings/oleObject4.bin"/><Relationship Id="rId10" Type="http://schemas.openxmlformats.org/officeDocument/2006/relationships/image" Target="../media/image14.png"/><Relationship Id="rId4" Type="http://schemas.openxmlformats.org/officeDocument/2006/relationships/image" Target="../media/image10.png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328C62C-8361-FEAD-A96D-46DDEF9272BC}"/>
              </a:ext>
            </a:extLst>
          </p:cNvPr>
          <p:cNvSpPr txBox="1"/>
          <p:nvPr/>
        </p:nvSpPr>
        <p:spPr>
          <a:xfrm>
            <a:off x="377902" y="478734"/>
            <a:ext cx="53619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ouse models used in this study.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F3095BF-D406-D157-C37C-47BD70F213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8944954"/>
              </p:ext>
            </p:extLst>
          </p:nvPr>
        </p:nvGraphicFramePr>
        <p:xfrm>
          <a:off x="457527" y="762703"/>
          <a:ext cx="5999114" cy="5188366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821300">
                  <a:extLst>
                    <a:ext uri="{9D8B030D-6E8A-4147-A177-3AD203B41FA5}">
                      <a16:colId xmlns:a16="http://schemas.microsoft.com/office/drawing/2014/main" val="1119074329"/>
                    </a:ext>
                  </a:extLst>
                </a:gridCol>
                <a:gridCol w="1071051">
                  <a:extLst>
                    <a:ext uri="{9D8B030D-6E8A-4147-A177-3AD203B41FA5}">
                      <a16:colId xmlns:a16="http://schemas.microsoft.com/office/drawing/2014/main" val="2769746422"/>
                    </a:ext>
                  </a:extLst>
                </a:gridCol>
                <a:gridCol w="970496">
                  <a:extLst>
                    <a:ext uri="{9D8B030D-6E8A-4147-A177-3AD203B41FA5}">
                      <a16:colId xmlns:a16="http://schemas.microsoft.com/office/drawing/2014/main" val="3939379216"/>
                    </a:ext>
                  </a:extLst>
                </a:gridCol>
                <a:gridCol w="1562911">
                  <a:extLst>
                    <a:ext uri="{9D8B030D-6E8A-4147-A177-3AD203B41FA5}">
                      <a16:colId xmlns:a16="http://schemas.microsoft.com/office/drawing/2014/main" val="1434437343"/>
                    </a:ext>
                  </a:extLst>
                </a:gridCol>
                <a:gridCol w="1573356">
                  <a:extLst>
                    <a:ext uri="{9D8B030D-6E8A-4147-A177-3AD203B41FA5}">
                      <a16:colId xmlns:a16="http://schemas.microsoft.com/office/drawing/2014/main" val="3649592205"/>
                    </a:ext>
                  </a:extLst>
                </a:gridCol>
              </a:tblGrid>
              <a:tr h="17691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stra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breviations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knockout strategy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ucible or noninducibl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(s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3596236"/>
                  </a:ext>
                </a:extLst>
              </a:tr>
              <a:tr h="3996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llin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r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r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-LoxP syste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 heterozygous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eleti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ury et al. (2022), PMCID: PMC92456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6507629"/>
                  </a:ext>
                </a:extLst>
              </a:tr>
              <a:tr h="3996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n-US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</a:t>
                      </a:r>
                      <a:r>
                        <a:rPr lang="el-GR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l-GR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llinCr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n-US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</a:t>
                      </a:r>
                      <a:r>
                        <a:rPr lang="el-GR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l-GR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r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-LoxP syste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 heterozygous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FASN deleti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ury et al. (2022), PMCID: PMC92456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3586825"/>
                  </a:ext>
                </a:extLst>
              </a:tr>
              <a:tr h="3996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l-GR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/Δ</a:t>
                      </a:r>
                      <a:r>
                        <a:rPr lang="el-GR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llinCre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l-GR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/Δ</a:t>
                      </a:r>
                      <a:r>
                        <a:rPr lang="el-GR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re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-LoxP system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 heterozygous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homozygous FASN deleti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ury et al. (2022), PMCID: PMC92456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5159753"/>
                  </a:ext>
                </a:extLst>
              </a:tr>
              <a:tr h="3996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llinCreE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oxifen inducible Cre recombina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ucible Apc deletio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ury et al. (2022), PMCID: PMC92456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6672501"/>
                  </a:ext>
                </a:extLst>
              </a:tr>
              <a:tr h="3996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n-US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</a:t>
                      </a:r>
                      <a:r>
                        <a:rPr lang="el-GR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l-GR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VillinCreE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n-US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</a:t>
                      </a:r>
                      <a:r>
                        <a:rPr lang="el-GR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l-GR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E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oxifen inducible Cre recombina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ucible Apc and heterozygous FASN deletio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ury et al. (2022), PMCID: PMC92456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9848436"/>
                  </a:ext>
                </a:extLst>
              </a:tr>
              <a:tr h="3996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l-GR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/Δ</a:t>
                      </a:r>
                      <a:r>
                        <a:rPr lang="el-GR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VillinCreE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l-GR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/Δ</a:t>
                      </a:r>
                      <a:r>
                        <a:rPr lang="el-GR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E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oxifen inducible Cre recombina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ucible Apc and homozygous FASN deletio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ury et al. (2022), PMCID: PMC92456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3948926"/>
                  </a:ext>
                </a:extLst>
              </a:tr>
              <a:tr h="3205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ically induced mutation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 heterozygous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eleti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ser et al. (1990) PMID: 229672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1149999"/>
                  </a:ext>
                </a:extLst>
              </a:tr>
              <a:tr h="3996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i="0" u="none" strike="noStrike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VillinCreERT2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u="none" strike="noStrike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E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oxifen inducible Cre recombina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 specific induction of Cre recombinas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aytseva lab: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Min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x VillinCreE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6322383"/>
                  </a:ext>
                </a:extLst>
              </a:tr>
              <a:tr h="3996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i="0" u="none" strike="noStrike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n-US" sz="1000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</a:t>
                      </a:r>
                      <a:r>
                        <a:rPr lang="el-GR" sz="1000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l-GR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llinCreE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000" i="0" u="none" strike="noStrike" baseline="30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</a:t>
                      </a:r>
                      <a:r>
                        <a:rPr lang="en-US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n-US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</a:t>
                      </a:r>
                      <a:r>
                        <a:rPr lang="el-GR" sz="1000" i="1" u="none" strike="noStrike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l-GR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oxifen inducible Cre recombina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ucible heterozygous Fasn deletio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aytseva lab: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Min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X </a:t>
                      </a:r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/</a:t>
                      </a:r>
                      <a:r>
                        <a:rPr lang="el-GR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/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llinCreER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21918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103076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328C62C-8361-FEAD-A96D-46DDEF9272BC}"/>
              </a:ext>
            </a:extLst>
          </p:cNvPr>
          <p:cNvSpPr txBox="1"/>
          <p:nvPr/>
        </p:nvSpPr>
        <p:spPr>
          <a:xfrm>
            <a:off x="748016" y="511391"/>
            <a:ext cx="536196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2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expression of stem cell markers in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Cre and </a:t>
            </a:r>
            <a:r>
              <a:rPr lang="en-US" sz="1100" i="1" dirty="0">
                <a:latin typeface="Arial" panose="020B0604020202020204" pitchFamily="34" charset="0"/>
              </a:rPr>
              <a:t>Fasn</a:t>
            </a:r>
            <a:r>
              <a:rPr lang="el-GR" sz="1100" baseline="30000" dirty="0">
                <a:latin typeface="Arial" panose="020B0604020202020204" pitchFamily="34" charset="0"/>
              </a:rPr>
              <a:t>Δ</a:t>
            </a:r>
            <a:r>
              <a:rPr lang="en-US" sz="1100" baseline="30000" dirty="0">
                <a:latin typeface="Arial" panose="020B0604020202020204" pitchFamily="34" charset="0"/>
              </a:rPr>
              <a:t>/</a:t>
            </a:r>
            <a:r>
              <a:rPr lang="el-GR" sz="1100" baseline="30000" dirty="0">
                <a:latin typeface="Arial" panose="020B0604020202020204" pitchFamily="34" charset="0"/>
              </a:rPr>
              <a:t>Δ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Cre adenomas using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RNAseq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alysis.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4D805B68-DBF5-EFCD-0D9D-2C154C2819CE}"/>
              </a:ext>
            </a:extLst>
          </p:cNvPr>
          <p:cNvGraphicFramePr>
            <a:graphicFrameLocks noGrp="1"/>
          </p:cNvGraphicFramePr>
          <p:nvPr/>
        </p:nvGraphicFramePr>
        <p:xfrm>
          <a:off x="748016" y="986134"/>
          <a:ext cx="5361969" cy="1677138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683248">
                  <a:extLst>
                    <a:ext uri="{9D8B030D-6E8A-4147-A177-3AD203B41FA5}">
                      <a16:colId xmlns:a16="http://schemas.microsoft.com/office/drawing/2014/main" val="3016830233"/>
                    </a:ext>
                  </a:extLst>
                </a:gridCol>
                <a:gridCol w="777068">
                  <a:extLst>
                    <a:ext uri="{9D8B030D-6E8A-4147-A177-3AD203B41FA5}">
                      <a16:colId xmlns:a16="http://schemas.microsoft.com/office/drawing/2014/main" val="2622843305"/>
                    </a:ext>
                  </a:extLst>
                </a:gridCol>
                <a:gridCol w="781146">
                  <a:extLst>
                    <a:ext uri="{9D8B030D-6E8A-4147-A177-3AD203B41FA5}">
                      <a16:colId xmlns:a16="http://schemas.microsoft.com/office/drawing/2014/main" val="2164995272"/>
                    </a:ext>
                  </a:extLst>
                </a:gridCol>
                <a:gridCol w="1366497">
                  <a:extLst>
                    <a:ext uri="{9D8B030D-6E8A-4147-A177-3AD203B41FA5}">
                      <a16:colId xmlns:a16="http://schemas.microsoft.com/office/drawing/2014/main" val="3221334828"/>
                    </a:ext>
                  </a:extLst>
                </a:gridCol>
                <a:gridCol w="877005">
                  <a:extLst>
                    <a:ext uri="{9D8B030D-6E8A-4147-A177-3AD203B41FA5}">
                      <a16:colId xmlns:a16="http://schemas.microsoft.com/office/drawing/2014/main" val="2566725549"/>
                    </a:ext>
                  </a:extLst>
                </a:gridCol>
                <a:gridCol w="877005">
                  <a:extLst>
                    <a:ext uri="{9D8B030D-6E8A-4147-A177-3AD203B41FA5}">
                      <a16:colId xmlns:a16="http://schemas.microsoft.com/office/drawing/2014/main" val="3135172639"/>
                    </a:ext>
                  </a:extLst>
                </a:gridCol>
              </a:tblGrid>
              <a:tr h="149095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re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∆/∆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2FoldChange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R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</a:p>
                  </a:txBody>
                  <a:tcPr marL="47625" marR="47625" marT="0" marB="0" anchor="ctr"/>
                </a:tc>
                <a:extLst>
                  <a:ext uri="{0D108BD9-81ED-4DB2-BD59-A6C34878D82A}">
                    <a16:rowId xmlns:a16="http://schemas.microsoft.com/office/drawing/2014/main" val="352057215"/>
                  </a:ext>
                </a:extLst>
              </a:tr>
              <a:tr h="223643"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N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54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709005968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25" marR="47625" marT="0" marB="0" anchor="ctr"/>
                </a:tc>
                <a:extLst>
                  <a:ext uri="{0D108BD9-81ED-4DB2-BD59-A6C34878D82A}">
                    <a16:rowId xmlns:a16="http://schemas.microsoft.com/office/drawing/2014/main" val="108538924"/>
                  </a:ext>
                </a:extLst>
              </a:tr>
              <a:tr h="223643"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um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2.85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951932244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25" marR="47625" marT="0" marB="0" anchor="ctr"/>
                </a:tc>
                <a:extLst>
                  <a:ext uri="{0D108BD9-81ED-4DB2-BD59-A6C34878D82A}">
                    <a16:rowId xmlns:a16="http://schemas.microsoft.com/office/drawing/2014/main" val="2241683279"/>
                  </a:ext>
                </a:extLst>
              </a:tr>
              <a:tr h="223643"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11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431674384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25" marR="47625" marT="0" marB="0" anchor="ctr"/>
                </a:tc>
                <a:extLst>
                  <a:ext uri="{0D108BD9-81ED-4DB2-BD59-A6C34878D82A}">
                    <a16:rowId xmlns:a16="http://schemas.microsoft.com/office/drawing/2014/main" val="3902836457"/>
                  </a:ext>
                </a:extLst>
              </a:tr>
              <a:tr h="223643"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cam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36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8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199308808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x10</a:t>
                      </a:r>
                      <a:r>
                        <a:rPr lang="en-US" sz="1100" b="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160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x10</a:t>
                      </a:r>
                      <a:r>
                        <a:rPr lang="en-US" sz="1100" b="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161</a:t>
                      </a:r>
                      <a:endParaRPr lang="en-US" sz="11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/>
                </a:tc>
                <a:extLst>
                  <a:ext uri="{0D108BD9-81ED-4DB2-BD59-A6C34878D82A}">
                    <a16:rowId xmlns:a16="http://schemas.microsoft.com/office/drawing/2014/main" val="2179176074"/>
                  </a:ext>
                </a:extLst>
              </a:tr>
              <a:tr h="223643"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R5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05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131856961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25" marR="47625" marT="0" marB="0" anchor="ctr"/>
                </a:tc>
                <a:extLst>
                  <a:ext uri="{0D108BD9-81ED-4DB2-BD59-A6C34878D82A}">
                    <a16:rowId xmlns:a16="http://schemas.microsoft.com/office/drawing/2014/main" val="1308728295"/>
                  </a:ext>
                </a:extLst>
              </a:tr>
              <a:tr h="223643"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nnb1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7.24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6.07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12665011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7625" marR="47625" marT="0" marB="0" anchor="ctr"/>
                </a:tc>
                <a:extLst>
                  <a:ext uri="{0D108BD9-81ED-4DB2-BD59-A6C34878D82A}">
                    <a16:rowId xmlns:a16="http://schemas.microsoft.com/office/drawing/2014/main" val="1447001009"/>
                  </a:ext>
                </a:extLst>
              </a:tr>
              <a:tr h="149095"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6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9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29283017</a:t>
                      </a: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34x10</a:t>
                      </a:r>
                      <a:r>
                        <a:rPr lang="en-US" sz="1100" b="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177</a:t>
                      </a:r>
                      <a:endParaRPr lang="en-US" sz="11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7x10</a:t>
                      </a:r>
                      <a:r>
                        <a:rPr lang="en-US" sz="1100" b="0" baseline="30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178</a:t>
                      </a:r>
                      <a:endParaRPr lang="en-US" sz="1100" b="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/>
                </a:tc>
                <a:extLst>
                  <a:ext uri="{0D108BD9-81ED-4DB2-BD59-A6C34878D82A}">
                    <a16:rowId xmlns:a16="http://schemas.microsoft.com/office/drawing/2014/main" val="18135044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05770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4D2B76C-D3AE-D269-C136-71B656E6A9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471397"/>
              </p:ext>
            </p:extLst>
          </p:nvPr>
        </p:nvGraphicFramePr>
        <p:xfrm>
          <a:off x="641878" y="789215"/>
          <a:ext cx="5361968" cy="1539240"/>
        </p:xfrm>
        <a:graphic>
          <a:graphicData uri="http://schemas.openxmlformats.org/drawingml/2006/table">
            <a:tbl>
              <a:tblPr firstRow="1">
                <a:tableStyleId>{2D5ABB26-0587-4C30-8999-92F81FD0307C}</a:tableStyleId>
              </a:tblPr>
              <a:tblGrid>
                <a:gridCol w="754215">
                  <a:extLst>
                    <a:ext uri="{9D8B030D-6E8A-4147-A177-3AD203B41FA5}">
                      <a16:colId xmlns:a16="http://schemas.microsoft.com/office/drawing/2014/main" val="2619737336"/>
                    </a:ext>
                  </a:extLst>
                </a:gridCol>
                <a:gridCol w="2405267">
                  <a:extLst>
                    <a:ext uri="{9D8B030D-6E8A-4147-A177-3AD203B41FA5}">
                      <a16:colId xmlns:a16="http://schemas.microsoft.com/office/drawing/2014/main" val="3404160126"/>
                    </a:ext>
                  </a:extLst>
                </a:gridCol>
                <a:gridCol w="2202486">
                  <a:extLst>
                    <a:ext uri="{9D8B030D-6E8A-4147-A177-3AD203B41FA5}">
                      <a16:colId xmlns:a16="http://schemas.microsoft.com/office/drawing/2014/main" val="482254871"/>
                    </a:ext>
                  </a:extLst>
                </a:gridCol>
              </a:tblGrid>
              <a:tr h="149805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Cell Line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APC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l-GR" sz="1100" b="1" dirty="0"/>
                        <a:t>β</a:t>
                      </a:r>
                      <a:r>
                        <a:rPr lang="en-US" sz="1100" b="1" dirty="0"/>
                        <a:t>-catenin (CTNNBL1)</a:t>
                      </a:r>
                      <a:endParaRPr 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1989943"/>
                  </a:ext>
                </a:extLst>
              </a:tr>
              <a:tr h="246738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SW480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Mutant </a:t>
                      </a:r>
                    </a:p>
                    <a:p>
                      <a:pPr algn="ctr"/>
                      <a:r>
                        <a:rPr lang="en-US" sz="1100" dirty="0"/>
                        <a:t>(c.40121C&gt;T/p. Gln1338*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Wild-type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4221209"/>
                  </a:ext>
                </a:extLst>
              </a:tr>
              <a:tr h="246738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HT29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Mutant </a:t>
                      </a:r>
                    </a:p>
                    <a:p>
                      <a:pPr algn="ctr"/>
                      <a:r>
                        <a:rPr lang="en-US" sz="1100" dirty="0"/>
                        <a:t>(c.2557G&gt;T/p. Glu 853*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Wild-type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2560188"/>
                  </a:ext>
                </a:extLst>
              </a:tr>
              <a:tr h="34367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HCT116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Wild-type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Mutant (c.133_135delTCT/p.Ser45del</a:t>
                      </a:r>
                      <a:r>
                        <a:rPr lang="en-US" sz="1100" baseline="0" dirty="0"/>
                        <a:t>)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794295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A7F793A5-2A3C-3971-C097-C17D4F2760D5}"/>
              </a:ext>
            </a:extLst>
          </p:cNvPr>
          <p:cNvSpPr txBox="1"/>
          <p:nvPr/>
        </p:nvSpPr>
        <p:spPr>
          <a:xfrm>
            <a:off x="641878" y="330036"/>
            <a:ext cx="53619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3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mutational statuses of APC and β-catenin in CRC cells. </a:t>
            </a:r>
          </a:p>
        </p:txBody>
      </p:sp>
    </p:spTree>
    <p:extLst>
      <p:ext uri="{BB962C8B-B14F-4D97-AF65-F5344CB8AC3E}">
        <p14:creationId xmlns:p14="http://schemas.microsoft.com/office/powerpoint/2010/main" val="18707414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976142D4-7918-04F1-2E8B-61C5F70F8F7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3622"/>
          <a:stretch/>
        </p:blipFill>
        <p:spPr>
          <a:xfrm>
            <a:off x="796217" y="389794"/>
            <a:ext cx="1837944" cy="119687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23CC65D-42E0-C8DE-6370-BA59DB02C07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3573"/>
          <a:stretch/>
        </p:blipFill>
        <p:spPr>
          <a:xfrm>
            <a:off x="796218" y="1662746"/>
            <a:ext cx="1837943" cy="119620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29C6130-52E4-E5B5-405A-B8362C6EDD34}"/>
              </a:ext>
            </a:extLst>
          </p:cNvPr>
          <p:cNvSpPr txBox="1"/>
          <p:nvPr/>
        </p:nvSpPr>
        <p:spPr>
          <a:xfrm rot="16200000">
            <a:off x="73358" y="860613"/>
            <a:ext cx="11878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1EF3A34-C141-F055-1366-7BDA7BE7AFC7}"/>
              </a:ext>
            </a:extLst>
          </p:cNvPr>
          <p:cNvSpPr txBox="1"/>
          <p:nvPr/>
        </p:nvSpPr>
        <p:spPr>
          <a:xfrm rot="16200000">
            <a:off x="73360" y="2133561"/>
            <a:ext cx="11878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-OH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D59EC84-8D23-18DF-8CB7-36A94CE87AB6}"/>
              </a:ext>
            </a:extLst>
          </p:cNvPr>
          <p:cNvSpPr txBox="1"/>
          <p:nvPr/>
        </p:nvSpPr>
        <p:spPr>
          <a:xfrm>
            <a:off x="307237" y="3231669"/>
            <a:ext cx="6171749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l Figure S1. 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reatment with 4-OHT does not significantly affect normal and tumor organoid growth.</a:t>
            </a:r>
            <a:r>
              <a:rPr lang="en-US" sz="11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(A) </a:t>
            </a:r>
            <a:r>
              <a:rPr lang="en-US" sz="1100" i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pc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/CreERT2 and</a:t>
            </a:r>
            <a:r>
              <a:rPr lang="en-US" sz="11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(B) </a:t>
            </a:r>
            <a:r>
              <a:rPr lang="en-US" sz="1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pc</a:t>
            </a:r>
            <a:r>
              <a:rPr lang="en-US" sz="1100" baseline="300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in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organoids were exposed to 4-OHT for 24 h and imaged on day 5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11A30E-1E81-06B5-0CE8-AF5E79B3394E}"/>
              </a:ext>
            </a:extLst>
          </p:cNvPr>
          <p:cNvSpPr txBox="1"/>
          <p:nvPr/>
        </p:nvSpPr>
        <p:spPr>
          <a:xfrm>
            <a:off x="526864" y="113208"/>
            <a:ext cx="2808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607BC67-7F77-D37C-0BCA-2A2EA07F31A0}"/>
              </a:ext>
            </a:extLst>
          </p:cNvPr>
          <p:cNvSpPr txBox="1"/>
          <p:nvPr/>
        </p:nvSpPr>
        <p:spPr>
          <a:xfrm>
            <a:off x="2985588" y="113208"/>
            <a:ext cx="279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B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64C349F0-A28F-F872-D416-770EEE8F77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4766281"/>
              </p:ext>
            </p:extLst>
          </p:nvPr>
        </p:nvGraphicFramePr>
        <p:xfrm>
          <a:off x="2949877" y="262897"/>
          <a:ext cx="1812341" cy="19963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9" r:id="rId5" imgW="2518429" imgH="2773186" progId="Prism9.Document">
                  <p:embed/>
                </p:oleObj>
              </mc:Choice>
              <mc:Fallback>
                <p:oleObj name="Prism 9" r:id="rId5" imgW="2518429" imgH="2773186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91D7D68B-290A-4D9D-90F4-2B0FC427BDA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949877" y="262897"/>
                        <a:ext cx="1812341" cy="19963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5" name="Picture 14">
            <a:extLst>
              <a:ext uri="{FF2B5EF4-FFF2-40B4-BE49-F238E27FC236}">
                <a16:creationId xmlns:a16="http://schemas.microsoft.com/office/drawing/2014/main" id="{2F4BD599-471A-2B3B-7679-8395907FD06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1632"/>
          <a:stretch/>
        </p:blipFill>
        <p:spPr>
          <a:xfrm>
            <a:off x="4762218" y="1662733"/>
            <a:ext cx="1602794" cy="119619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A663AB1-35D4-89B1-7E07-ADBA188FD92D}"/>
              </a:ext>
            </a:extLst>
          </p:cNvPr>
          <p:cNvSpPr txBox="1"/>
          <p:nvPr/>
        </p:nvSpPr>
        <p:spPr>
          <a:xfrm>
            <a:off x="1447618" y="2858947"/>
            <a:ext cx="11865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/>
              <a:t>Scale bar=300 </a:t>
            </a:r>
            <a:r>
              <a:rPr lang="en-US" sz="1000" dirty="0" err="1"/>
              <a:t>μm</a:t>
            </a:r>
            <a:endParaRPr lang="en-US" sz="1000" dirty="0"/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88F30D1D-B845-D16C-D923-5F3EC1AAB94D}"/>
              </a:ext>
            </a:extLst>
          </p:cNvPr>
          <p:cNvCxnSpPr/>
          <p:nvPr/>
        </p:nvCxnSpPr>
        <p:spPr>
          <a:xfrm>
            <a:off x="2367757" y="1518341"/>
            <a:ext cx="17373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543A56BD-C43B-8F36-7B4B-12022F6F160F}"/>
              </a:ext>
            </a:extLst>
          </p:cNvPr>
          <p:cNvCxnSpPr/>
          <p:nvPr/>
        </p:nvCxnSpPr>
        <p:spPr>
          <a:xfrm>
            <a:off x="2367757" y="2790828"/>
            <a:ext cx="17373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3D34C8B3-78EF-46FB-D4C6-8A11861E20CE}"/>
              </a:ext>
            </a:extLst>
          </p:cNvPr>
          <p:cNvSpPr txBox="1"/>
          <p:nvPr/>
        </p:nvSpPr>
        <p:spPr>
          <a:xfrm>
            <a:off x="5185878" y="2858947"/>
            <a:ext cx="11865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/>
              <a:t>Scale bar=100 </a:t>
            </a:r>
            <a:r>
              <a:rPr lang="en-US" sz="1000" dirty="0" err="1"/>
              <a:t>μm</a:t>
            </a:r>
            <a:endParaRPr lang="en-US" sz="1000" dirty="0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04DA57D4-4AF3-1FCD-1D76-1C8C56CD039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51632"/>
          <a:stretch/>
        </p:blipFill>
        <p:spPr>
          <a:xfrm>
            <a:off x="4762218" y="384043"/>
            <a:ext cx="1599321" cy="1193601"/>
          </a:xfrm>
          <a:prstGeom prst="rect">
            <a:avLst/>
          </a:prstGeom>
        </p:spPr>
      </p:pic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F5672DB-B540-9709-45E6-D5C16D9F12DD}"/>
              </a:ext>
            </a:extLst>
          </p:cNvPr>
          <p:cNvCxnSpPr/>
          <p:nvPr/>
        </p:nvCxnSpPr>
        <p:spPr>
          <a:xfrm>
            <a:off x="6141071" y="1492889"/>
            <a:ext cx="17373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48D4ABE-AE76-5E79-D1BF-1BE355E0AE3A}"/>
              </a:ext>
            </a:extLst>
          </p:cNvPr>
          <p:cNvCxnSpPr/>
          <p:nvPr/>
        </p:nvCxnSpPr>
        <p:spPr>
          <a:xfrm>
            <a:off x="6141071" y="2777253"/>
            <a:ext cx="17373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2D52F821-3033-824F-B4EA-D55A55159E7A}"/>
              </a:ext>
            </a:extLst>
          </p:cNvPr>
          <p:cNvSpPr txBox="1"/>
          <p:nvPr/>
        </p:nvSpPr>
        <p:spPr>
          <a:xfrm rot="16200000">
            <a:off x="4036678" y="860614"/>
            <a:ext cx="11878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B185A93-1ED4-B125-9AF4-8BABFD4D4627}"/>
              </a:ext>
            </a:extLst>
          </p:cNvPr>
          <p:cNvSpPr txBox="1"/>
          <p:nvPr/>
        </p:nvSpPr>
        <p:spPr>
          <a:xfrm rot="16200000">
            <a:off x="4036680" y="2133562"/>
            <a:ext cx="11878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-OHT</a:t>
            </a:r>
          </a:p>
        </p:txBody>
      </p:sp>
    </p:spTree>
    <p:extLst>
      <p:ext uri="{BB962C8B-B14F-4D97-AF65-F5344CB8AC3E}">
        <p14:creationId xmlns:p14="http://schemas.microsoft.com/office/powerpoint/2010/main" val="7307366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549251B-7277-9A36-E893-667FE5A4F38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6343858"/>
              </p:ext>
            </p:extLst>
          </p:nvPr>
        </p:nvGraphicFramePr>
        <p:xfrm>
          <a:off x="1086812" y="152416"/>
          <a:ext cx="2475740" cy="36843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Prism 9" r:id="rId3" imgW="2488178" imgH="3702023" progId="Prism9.Document">
                  <p:embed/>
                </p:oleObj>
              </mc:Choice>
              <mc:Fallback>
                <p:oleObj name="Prism 9" r:id="rId3" imgW="2488178" imgH="3702023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92C3A45F-F14E-3711-6FF8-AB91D7443A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86812" y="152416"/>
                        <a:ext cx="2475740" cy="36843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BBCB019-59AF-FBAD-90F8-0B50789056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3392935"/>
              </p:ext>
            </p:extLst>
          </p:nvPr>
        </p:nvGraphicFramePr>
        <p:xfrm>
          <a:off x="3546287" y="152417"/>
          <a:ext cx="2475741" cy="36843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" name="Prism 9" r:id="rId5" imgW="2488178" imgH="3702023" progId="Prism9.Document">
                  <p:embed/>
                </p:oleObj>
              </mc:Choice>
              <mc:Fallback>
                <p:oleObj name="Prism 9" r:id="rId5" imgW="2488178" imgH="3702023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A71CEFBA-5C84-BEC3-7B51-4698BE9B651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46287" y="152417"/>
                        <a:ext cx="2475741" cy="36843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142A8B9-3A8C-5D66-4ECC-696052399C55}"/>
              </a:ext>
            </a:extLst>
          </p:cNvPr>
          <p:cNvSpPr txBox="1"/>
          <p:nvPr/>
        </p:nvSpPr>
        <p:spPr>
          <a:xfrm>
            <a:off x="337279" y="3971836"/>
            <a:ext cx="612648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tic inhibition of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ecreases mRNA levels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Notum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inducible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en-US" sz="11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rganoids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PCR analysis of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Notu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 control and 4-OHT treated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r>
              <a:rPr lang="en-US" sz="11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/</a:t>
            </a:r>
            <a:r>
              <a:rPr lang="en-US" sz="11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ERT2 organoid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079F4E7-ACD9-D016-2BCD-5D7DCD2E0E98}"/>
              </a:ext>
            </a:extLst>
          </p:cNvPr>
          <p:cNvSpPr txBox="1"/>
          <p:nvPr/>
        </p:nvSpPr>
        <p:spPr>
          <a:xfrm>
            <a:off x="825553" y="26853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F03D3C0-0B6A-1B1A-7A56-45CBCBB8D37E}"/>
              </a:ext>
            </a:extLst>
          </p:cNvPr>
          <p:cNvSpPr txBox="1"/>
          <p:nvPr/>
        </p:nvSpPr>
        <p:spPr>
          <a:xfrm>
            <a:off x="3400519" y="26853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11BD8FC-9751-00B7-C747-D25FE0F35A10}"/>
              </a:ext>
            </a:extLst>
          </p:cNvPr>
          <p:cNvSpPr txBox="1"/>
          <p:nvPr/>
        </p:nvSpPr>
        <p:spPr>
          <a:xfrm>
            <a:off x="1920607" y="240551"/>
            <a:ext cx="122287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 err="1"/>
              <a:t>Fasn</a:t>
            </a:r>
            <a:endParaRPr lang="en-US" sz="1400" b="1" i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2CAC09B-28D4-11DF-2155-FA9D54ED4F03}"/>
              </a:ext>
            </a:extLst>
          </p:cNvPr>
          <p:cNvSpPr txBox="1"/>
          <p:nvPr/>
        </p:nvSpPr>
        <p:spPr>
          <a:xfrm>
            <a:off x="4410419" y="240551"/>
            <a:ext cx="122287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/>
              <a:t>Notum</a:t>
            </a:r>
          </a:p>
        </p:txBody>
      </p:sp>
    </p:spTree>
    <p:extLst>
      <p:ext uri="{BB962C8B-B14F-4D97-AF65-F5344CB8AC3E}">
        <p14:creationId xmlns:p14="http://schemas.microsoft.com/office/powerpoint/2010/main" val="3030762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8D3A764-C656-036B-1174-966F47F84600}"/>
              </a:ext>
            </a:extLst>
          </p:cNvPr>
          <p:cNvSpPr txBox="1"/>
          <p:nvPr/>
        </p:nvSpPr>
        <p:spPr>
          <a:xfrm>
            <a:off x="418321" y="8284975"/>
            <a:ext cx="611777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effect of TVB-3664 treatment on growth of patient-derived CRC organoids. Representative images were taken daily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12D2D2C-200B-B98D-4A55-FAD893A7C3DA}"/>
              </a:ext>
            </a:extLst>
          </p:cNvPr>
          <p:cNvSpPr txBox="1"/>
          <p:nvPr/>
        </p:nvSpPr>
        <p:spPr>
          <a:xfrm>
            <a:off x="1382546" y="391136"/>
            <a:ext cx="6879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ay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14B99E4-C7C5-E750-94A8-E0BD3DC117B9}"/>
              </a:ext>
            </a:extLst>
          </p:cNvPr>
          <p:cNvSpPr txBox="1"/>
          <p:nvPr/>
        </p:nvSpPr>
        <p:spPr>
          <a:xfrm>
            <a:off x="1511432" y="1047952"/>
            <a:ext cx="308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/>
              <a:t>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5D38428-6486-9D33-CC71-EDF211835F84}"/>
              </a:ext>
            </a:extLst>
          </p:cNvPr>
          <p:cNvSpPr txBox="1"/>
          <p:nvPr/>
        </p:nvSpPr>
        <p:spPr>
          <a:xfrm>
            <a:off x="1511431" y="2110158"/>
            <a:ext cx="308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/>
              <a:t>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F75E51F-F629-4EFB-0E2E-C102B286A276}"/>
              </a:ext>
            </a:extLst>
          </p:cNvPr>
          <p:cNvSpPr txBox="1"/>
          <p:nvPr/>
        </p:nvSpPr>
        <p:spPr>
          <a:xfrm>
            <a:off x="1511430" y="3361555"/>
            <a:ext cx="308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/>
              <a:t>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FDE09E9-81B4-0CB9-E714-E62887CDF613}"/>
              </a:ext>
            </a:extLst>
          </p:cNvPr>
          <p:cNvSpPr txBox="1"/>
          <p:nvPr/>
        </p:nvSpPr>
        <p:spPr>
          <a:xfrm>
            <a:off x="1511429" y="4470159"/>
            <a:ext cx="308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/>
              <a:t>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3F3109A-6C6F-3B87-B1BF-9DE9A1C54707}"/>
              </a:ext>
            </a:extLst>
          </p:cNvPr>
          <p:cNvSpPr txBox="1"/>
          <p:nvPr/>
        </p:nvSpPr>
        <p:spPr>
          <a:xfrm>
            <a:off x="1875452" y="391136"/>
            <a:ext cx="15115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ontro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60CF33D-4D64-12F1-005B-CF855D6FE0EF}"/>
              </a:ext>
            </a:extLst>
          </p:cNvPr>
          <p:cNvSpPr txBox="1"/>
          <p:nvPr/>
        </p:nvSpPr>
        <p:spPr>
          <a:xfrm>
            <a:off x="1511428" y="5796535"/>
            <a:ext cx="308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/>
              <a:t>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ABAFDE1-816D-5729-E5CC-D38519CB8997}"/>
              </a:ext>
            </a:extLst>
          </p:cNvPr>
          <p:cNvSpPr txBox="1"/>
          <p:nvPr/>
        </p:nvSpPr>
        <p:spPr>
          <a:xfrm>
            <a:off x="1471448" y="7147963"/>
            <a:ext cx="308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6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2AD3ACD-68B3-21CA-15DC-F4BA930B8082}"/>
              </a:ext>
            </a:extLst>
          </p:cNvPr>
          <p:cNvSpPr txBox="1"/>
          <p:nvPr/>
        </p:nvSpPr>
        <p:spPr>
          <a:xfrm>
            <a:off x="3517640" y="391136"/>
            <a:ext cx="15208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TVB-3664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55D143D-79FA-4092-52E8-F9E04B12AF8D}"/>
              </a:ext>
            </a:extLst>
          </p:cNvPr>
          <p:cNvSpPr txBox="1"/>
          <p:nvPr/>
        </p:nvSpPr>
        <p:spPr>
          <a:xfrm>
            <a:off x="2725562" y="7892339"/>
            <a:ext cx="23953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cale bars= 200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µm</a:t>
            </a:r>
            <a:r>
              <a:rPr lang="en-US" sz="11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06BC228-3523-816F-586D-5FB509BD2B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6100" y="645886"/>
            <a:ext cx="3225800" cy="726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8959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59E3747-E5F8-1149-66FE-5E78BB5F1D86}"/>
              </a:ext>
            </a:extLst>
          </p:cNvPr>
          <p:cNvSpPr txBox="1"/>
          <p:nvPr/>
        </p:nvSpPr>
        <p:spPr>
          <a:xfrm>
            <a:off x="315685" y="6591715"/>
            <a:ext cx="611777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. Sentence goes here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>
                <a:solidFill>
                  <a:srgbClr val="3F3F3F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SAB treatment downregulates activ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β-catenin in a dose-dependent manner in SW480 cells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OTUM mRNA expression in SW480 cells transfected with control and Notum siRNA for 72h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RNA-mediated downregulation of Notum is associated with a decrease in Cyclin D expression. 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0444420C-148E-1F54-ABF7-FD9712EDDBD4}"/>
              </a:ext>
            </a:extLst>
          </p:cNvPr>
          <p:cNvGrpSpPr/>
          <p:nvPr/>
        </p:nvGrpSpPr>
        <p:grpSpPr>
          <a:xfrm>
            <a:off x="1341645" y="307652"/>
            <a:ext cx="4174710" cy="1514761"/>
            <a:chOff x="2466167" y="1587515"/>
            <a:chExt cx="5502057" cy="1996379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5D0635E-79FA-4F66-7EE4-69CFF1E7014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46739" y="2393884"/>
              <a:ext cx="2804160" cy="55880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C985EAF-B6B4-D0F1-47D4-C14051ADA4CA}"/>
                </a:ext>
              </a:extLst>
            </p:cNvPr>
            <p:cNvSpPr txBox="1"/>
            <p:nvPr/>
          </p:nvSpPr>
          <p:spPr>
            <a:xfrm>
              <a:off x="6750899" y="2336825"/>
              <a:ext cx="1217325" cy="6895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ve </a:t>
              </a: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β-catenin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B2FC409-CDB2-A155-1CBE-03D90E078201}"/>
                </a:ext>
              </a:extLst>
            </p:cNvPr>
            <p:cNvSpPr txBox="1"/>
            <p:nvPr/>
          </p:nvSpPr>
          <p:spPr>
            <a:xfrm>
              <a:off x="3497156" y="2549832"/>
              <a:ext cx="505352" cy="4056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9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1742E2F-5699-2BEC-19E0-A65B48845C57}"/>
                </a:ext>
              </a:extLst>
            </p:cNvPr>
            <p:cNvSpPr txBox="1"/>
            <p:nvPr/>
          </p:nvSpPr>
          <p:spPr>
            <a:xfrm>
              <a:off x="4037655" y="2102526"/>
              <a:ext cx="355352" cy="3650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DACA560-6BFB-5558-4489-0AAB5B92CD84}"/>
                </a:ext>
              </a:extLst>
            </p:cNvPr>
            <p:cNvSpPr txBox="1"/>
            <p:nvPr/>
          </p:nvSpPr>
          <p:spPr>
            <a:xfrm>
              <a:off x="4355298" y="2102526"/>
              <a:ext cx="524367" cy="3650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93431D2-110C-2F31-F40C-82157B64B4C8}"/>
                </a:ext>
              </a:extLst>
            </p:cNvPr>
            <p:cNvSpPr txBox="1"/>
            <p:nvPr/>
          </p:nvSpPr>
          <p:spPr>
            <a:xfrm>
              <a:off x="4730528" y="2102526"/>
              <a:ext cx="524367" cy="3650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.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812EE60-4335-FD01-6BD9-4165143F927F}"/>
                </a:ext>
              </a:extLst>
            </p:cNvPr>
            <p:cNvSpPr txBox="1"/>
            <p:nvPr/>
          </p:nvSpPr>
          <p:spPr>
            <a:xfrm>
              <a:off x="5211294" y="2102526"/>
              <a:ext cx="524367" cy="3650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59A4B55-4502-CB5F-D14F-8E6E50401BE1}"/>
                </a:ext>
              </a:extLst>
            </p:cNvPr>
            <p:cNvSpPr txBox="1"/>
            <p:nvPr/>
          </p:nvSpPr>
          <p:spPr>
            <a:xfrm>
              <a:off x="5606767" y="2102526"/>
              <a:ext cx="355352" cy="3650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43A4DAA-33F0-F994-C75A-F87329991C1E}"/>
                </a:ext>
              </a:extLst>
            </p:cNvPr>
            <p:cNvSpPr txBox="1"/>
            <p:nvPr/>
          </p:nvSpPr>
          <p:spPr>
            <a:xfrm>
              <a:off x="5901847" y="2102526"/>
              <a:ext cx="467324" cy="3650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85E40BB-B6CF-4F58-E886-09EF08823165}"/>
                </a:ext>
              </a:extLst>
            </p:cNvPr>
            <p:cNvSpPr txBox="1"/>
            <p:nvPr/>
          </p:nvSpPr>
          <p:spPr>
            <a:xfrm>
              <a:off x="6320998" y="2102526"/>
              <a:ext cx="467324" cy="3650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D904DEA-482D-B42E-00BE-98D926E7EB45}"/>
                </a:ext>
              </a:extLst>
            </p:cNvPr>
            <p:cNvSpPr txBox="1"/>
            <p:nvPr/>
          </p:nvSpPr>
          <p:spPr>
            <a:xfrm>
              <a:off x="2466167" y="2102526"/>
              <a:ext cx="1536340" cy="4056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SAB (µM):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347B096-7B53-EAE8-FCC0-CCC40C1D6E34}"/>
                </a:ext>
              </a:extLst>
            </p:cNvPr>
            <p:cNvSpPr txBox="1"/>
            <p:nvPr/>
          </p:nvSpPr>
          <p:spPr>
            <a:xfrm>
              <a:off x="5030701" y="1587515"/>
              <a:ext cx="1018734" cy="4056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W480</a:t>
              </a:r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AB04DA0A-6C60-11AB-F5EB-BD836188617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46739" y="3025094"/>
              <a:ext cx="2815604" cy="558800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F448C22-7F68-B7FA-AF76-04735C3B9951}"/>
                </a:ext>
              </a:extLst>
            </p:cNvPr>
            <p:cNvSpPr txBox="1"/>
            <p:nvPr/>
          </p:nvSpPr>
          <p:spPr>
            <a:xfrm>
              <a:off x="6750899" y="3092134"/>
              <a:ext cx="769437" cy="4056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61A8483-77A9-CBCC-FDD5-383F7ECEEA28}"/>
                </a:ext>
              </a:extLst>
            </p:cNvPr>
            <p:cNvSpPr txBox="1"/>
            <p:nvPr/>
          </p:nvSpPr>
          <p:spPr>
            <a:xfrm>
              <a:off x="3497156" y="3119828"/>
              <a:ext cx="505352" cy="4056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05F5149E-2BA3-8DE6-8FD2-D87826A02192}"/>
              </a:ext>
            </a:extLst>
          </p:cNvPr>
          <p:cNvSpPr txBox="1"/>
          <p:nvPr/>
        </p:nvSpPr>
        <p:spPr>
          <a:xfrm>
            <a:off x="1050095" y="134082"/>
            <a:ext cx="439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4931E6C-CB9D-FD97-15CC-1FA6485B8DB9}"/>
              </a:ext>
            </a:extLst>
          </p:cNvPr>
          <p:cNvSpPr txBox="1"/>
          <p:nvPr/>
        </p:nvSpPr>
        <p:spPr>
          <a:xfrm>
            <a:off x="428525" y="2963151"/>
            <a:ext cx="506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BD99F2A2-482B-7E85-5797-BF08E8904A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8946916"/>
              </p:ext>
            </p:extLst>
          </p:nvPr>
        </p:nvGraphicFramePr>
        <p:xfrm>
          <a:off x="706821" y="2976667"/>
          <a:ext cx="2297823" cy="3117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Prism 9" r:id="rId5" imgW="2158653" imgH="2933455" progId="Prism9.Document">
                  <p:embed/>
                </p:oleObj>
              </mc:Choice>
              <mc:Fallback>
                <p:oleObj name="Prism 9" r:id="rId5" imgW="2158653" imgH="2933455" progId="Prism9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5B572701-4148-B74B-B32A-8199A721123E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06821" y="2976667"/>
                        <a:ext cx="2297823" cy="311775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2" name="Group 21">
            <a:extLst>
              <a:ext uri="{FF2B5EF4-FFF2-40B4-BE49-F238E27FC236}">
                <a16:creationId xmlns:a16="http://schemas.microsoft.com/office/drawing/2014/main" id="{5BE48045-AE83-E363-BB79-30EE44E0A8E9}"/>
              </a:ext>
            </a:extLst>
          </p:cNvPr>
          <p:cNvGrpSpPr/>
          <p:nvPr/>
        </p:nvGrpSpPr>
        <p:grpSpPr>
          <a:xfrm>
            <a:off x="3753921" y="2930885"/>
            <a:ext cx="3104079" cy="3057552"/>
            <a:chOff x="5668656" y="565018"/>
            <a:chExt cx="3104079" cy="3057552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9E96C525-3C71-539C-2876-ABC047B665A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068201" y="865757"/>
              <a:ext cx="956760" cy="506519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9DF8FD6-CC92-54AB-A892-1453E0491698}"/>
                </a:ext>
              </a:extLst>
            </p:cNvPr>
            <p:cNvSpPr txBox="1"/>
            <p:nvPr/>
          </p:nvSpPr>
          <p:spPr>
            <a:xfrm>
              <a:off x="7058123" y="970320"/>
              <a:ext cx="8796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ASN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E724F8D-A33B-DBD8-04F0-FFBB61F43CB5}"/>
                </a:ext>
              </a:extLst>
            </p:cNvPr>
            <p:cNvSpPr txBox="1"/>
            <p:nvPr/>
          </p:nvSpPr>
          <p:spPr>
            <a:xfrm>
              <a:off x="5668656" y="966964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6418A37-7B7C-2FE8-919E-D65ED9CA9876}"/>
                </a:ext>
              </a:extLst>
            </p:cNvPr>
            <p:cNvSpPr txBox="1"/>
            <p:nvPr/>
          </p:nvSpPr>
          <p:spPr>
            <a:xfrm>
              <a:off x="5901966" y="565018"/>
              <a:ext cx="8796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iCon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F9B9615-CD03-4E09-9DEF-A92020AD3241}"/>
                </a:ext>
              </a:extLst>
            </p:cNvPr>
            <p:cNvSpPr txBox="1"/>
            <p:nvPr/>
          </p:nvSpPr>
          <p:spPr>
            <a:xfrm>
              <a:off x="6446929" y="565018"/>
              <a:ext cx="13195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iNOTUM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C94C0265-D0D0-A101-F6C6-3CEEFF76B53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068201" y="1519069"/>
              <a:ext cx="977942" cy="434641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6E12419-7BA8-4A0E-498C-35E10458515E}"/>
                </a:ext>
              </a:extLst>
            </p:cNvPr>
            <p:cNvSpPr txBox="1"/>
            <p:nvPr/>
          </p:nvSpPr>
          <p:spPr>
            <a:xfrm>
              <a:off x="7058123" y="1529031"/>
              <a:ext cx="17146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ve β-catenin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CE7CE07-9AF2-FE3E-5851-86A7870A3340}"/>
                </a:ext>
              </a:extLst>
            </p:cNvPr>
            <p:cNvSpPr txBox="1"/>
            <p:nvPr/>
          </p:nvSpPr>
          <p:spPr>
            <a:xfrm>
              <a:off x="5768042" y="1533489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92</a:t>
              </a: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C745387C-6913-1E6E-6E25-00D9C3D1F67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068201" y="2666374"/>
              <a:ext cx="993895" cy="404523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AC31CAE-4FC2-4919-3FAB-8D07446BEFEF}"/>
                </a:ext>
              </a:extLst>
            </p:cNvPr>
            <p:cNvSpPr txBox="1"/>
            <p:nvPr/>
          </p:nvSpPr>
          <p:spPr>
            <a:xfrm>
              <a:off x="7058123" y="2741916"/>
              <a:ext cx="12702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yclin D1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F68E9F5-9445-E064-AA9D-E5BA6C3659DD}"/>
                </a:ext>
              </a:extLst>
            </p:cNvPr>
            <p:cNvSpPr txBox="1"/>
            <p:nvPr/>
          </p:nvSpPr>
          <p:spPr>
            <a:xfrm>
              <a:off x="5768042" y="268171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</a:p>
          </p:txBody>
        </p:sp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EC321C9B-55C3-8916-2EFB-84CF41C82F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068201" y="2120710"/>
              <a:ext cx="993895" cy="369332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2E0932B-9D37-D225-7A5B-20D7ACF13D9A}"/>
                </a:ext>
              </a:extLst>
            </p:cNvPr>
            <p:cNvSpPr txBox="1"/>
            <p:nvPr/>
          </p:nvSpPr>
          <p:spPr>
            <a:xfrm>
              <a:off x="7058123" y="2118260"/>
              <a:ext cx="9938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OTUM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07E4D97-1820-A0FB-0FA1-A5863ADD3C6E}"/>
                </a:ext>
              </a:extLst>
            </p:cNvPr>
            <p:cNvSpPr txBox="1"/>
            <p:nvPr/>
          </p:nvSpPr>
          <p:spPr>
            <a:xfrm>
              <a:off x="5768042" y="2147829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</a:p>
          </p:txBody>
        </p:sp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1A7A1276-0332-2C08-F530-0A42B5B248F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068201" y="3235430"/>
              <a:ext cx="995503" cy="387140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020351A1-8A43-6DC5-1F13-3DC9F95AD15B}"/>
                </a:ext>
              </a:extLst>
            </p:cNvPr>
            <p:cNvSpPr txBox="1"/>
            <p:nvPr/>
          </p:nvSpPr>
          <p:spPr>
            <a:xfrm>
              <a:off x="7058123" y="3208311"/>
              <a:ext cx="7242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0D3E038-220C-5AAA-DC6A-1C4D1927A5F8}"/>
                </a:ext>
              </a:extLst>
            </p:cNvPr>
            <p:cNvSpPr txBox="1"/>
            <p:nvPr/>
          </p:nvSpPr>
          <p:spPr>
            <a:xfrm>
              <a:off x="5768042" y="3226003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BD4A22A-67BF-644D-BE3B-84E1951DBB49}"/>
                </a:ext>
              </a:extLst>
            </p:cNvPr>
            <p:cNvSpPr txBox="1"/>
            <p:nvPr/>
          </p:nvSpPr>
          <p:spPr>
            <a:xfrm>
              <a:off x="6092476" y="2438735"/>
              <a:ext cx="498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7E481B28-B40B-8F16-8ED9-B59DEE5B383A}"/>
                </a:ext>
              </a:extLst>
            </p:cNvPr>
            <p:cNvSpPr txBox="1"/>
            <p:nvPr/>
          </p:nvSpPr>
          <p:spPr>
            <a:xfrm>
              <a:off x="6626552" y="2453635"/>
              <a:ext cx="4986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.47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864748E-E6E1-A0A4-A3DF-4EC187445394}"/>
                </a:ext>
              </a:extLst>
            </p:cNvPr>
            <p:cNvSpPr txBox="1"/>
            <p:nvPr/>
          </p:nvSpPr>
          <p:spPr>
            <a:xfrm>
              <a:off x="6075001" y="3012253"/>
              <a:ext cx="5830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4848FFE-0A4D-E96C-082C-3C833A70F262}"/>
                </a:ext>
              </a:extLst>
            </p:cNvPr>
            <p:cNvSpPr txBox="1"/>
            <p:nvPr/>
          </p:nvSpPr>
          <p:spPr>
            <a:xfrm>
              <a:off x="6555675" y="3024756"/>
              <a:ext cx="5780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.65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9080307-F5F5-B524-3E4C-445A241142F5}"/>
                </a:ext>
              </a:extLst>
            </p:cNvPr>
            <p:cNvSpPr txBox="1"/>
            <p:nvPr/>
          </p:nvSpPr>
          <p:spPr>
            <a:xfrm>
              <a:off x="6117182" y="1892676"/>
              <a:ext cx="498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C53D4B99-D527-3F07-E307-2C0213CE871E}"/>
                </a:ext>
              </a:extLst>
            </p:cNvPr>
            <p:cNvSpPr txBox="1"/>
            <p:nvPr/>
          </p:nvSpPr>
          <p:spPr>
            <a:xfrm>
              <a:off x="6597603" y="1902846"/>
              <a:ext cx="498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.21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1E10216C-07FF-D96D-39C5-CF15050A99F5}"/>
                </a:ext>
              </a:extLst>
            </p:cNvPr>
            <p:cNvSpPr txBox="1"/>
            <p:nvPr/>
          </p:nvSpPr>
          <p:spPr>
            <a:xfrm>
              <a:off x="6096000" y="1311907"/>
              <a:ext cx="498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02B19672-E361-6436-679B-A83AF1DFCB2E}"/>
                </a:ext>
              </a:extLst>
            </p:cNvPr>
            <p:cNvSpPr txBox="1"/>
            <p:nvPr/>
          </p:nvSpPr>
          <p:spPr>
            <a:xfrm>
              <a:off x="6581193" y="1303017"/>
              <a:ext cx="498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.01</a:t>
              </a:r>
            </a:p>
          </p:txBody>
        </p: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1CDC474D-66EE-6C35-1528-09154F39E3E8}"/>
              </a:ext>
            </a:extLst>
          </p:cNvPr>
          <p:cNvSpPr txBox="1"/>
          <p:nvPr/>
        </p:nvSpPr>
        <p:spPr>
          <a:xfrm>
            <a:off x="3472925" y="2963151"/>
            <a:ext cx="354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161061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6350"/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0</TotalTime>
  <Words>675</Words>
  <Application>Microsoft Office PowerPoint</Application>
  <PresentationFormat>Letter Paper (8.5x11 in)</PresentationFormat>
  <Paragraphs>178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nna</dc:creator>
  <cp:lastModifiedBy>MDPI</cp:lastModifiedBy>
  <cp:revision>25</cp:revision>
  <cp:lastPrinted>2024-06-11T19:39:45Z</cp:lastPrinted>
  <dcterms:created xsi:type="dcterms:W3CDTF">2024-06-11T13:54:13Z</dcterms:created>
  <dcterms:modified xsi:type="dcterms:W3CDTF">2024-10-08T09:02:27Z</dcterms:modified>
</cp:coreProperties>
</file>